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14630400" cy="109728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711F9-B5A5-4F44-A7A0-08BC3C1FE5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1316664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31880" y="6343200"/>
            <a:ext cx="1316664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67C99-7E80-44A1-BCEB-E9490B5E13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478640" y="256032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31880" y="634320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478640" y="634320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278D0-4E24-4D5C-B553-0CA8A8406E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423936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183640" y="2560320"/>
            <a:ext cx="423936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635400" y="2560320"/>
            <a:ext cx="423936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31880" y="6343200"/>
            <a:ext cx="423936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183640" y="6343200"/>
            <a:ext cx="423936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635400" y="6343200"/>
            <a:ext cx="423936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BFAB7-F923-4E37-8165-0C8925D228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31880" y="2560320"/>
            <a:ext cx="13166640" cy="7242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474"/>
              </a:spcBef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9F4BB-9734-4F53-8CEC-C9CC8EBD88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13166640" cy="724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68B22-540F-4B1C-8F8F-21BA57D502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6425280" cy="724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478640" y="2560320"/>
            <a:ext cx="6425280" cy="724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F5986-8E60-4231-BA6A-35439A12D2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8F6F2-FCC4-4CFC-BFB1-BA283A6BB1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31880" y="439560"/>
            <a:ext cx="13166640" cy="8478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474"/>
              </a:spcBef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6C3B7-4A6E-446F-A79D-C8FFB2D857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478640" y="2560320"/>
            <a:ext cx="6425280" cy="724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31880" y="634320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27013-3741-4CA6-8AF5-97D8DD1C19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6425280" cy="724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478640" y="256032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478640" y="634320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A7201-137B-4C13-B611-C78365EB5B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31880" y="256032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478640" y="2560320"/>
            <a:ext cx="642528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31880" y="6343200"/>
            <a:ext cx="13166640" cy="34542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/>
          </a:bodyPr>
          <a:p>
            <a:pPr indent="0">
              <a:spcBef>
                <a:spcPts val="1474"/>
              </a:spcBef>
              <a:buNone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1D07C-A015-4A85-A4FC-24F1CBD18C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31880" y="439560"/>
            <a:ext cx="13166640" cy="182880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ctr">
            <a:noAutofit/>
          </a:bodyPr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8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31880" y="2560320"/>
            <a:ext cx="13166640" cy="724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rmAutofit fontScale="95000"/>
          </a:bodyPr>
          <a:p>
            <a:pPr marL="595440" indent="-595440">
              <a:spcBef>
                <a:spcPts val="1474"/>
              </a:spcBef>
              <a:buClr>
                <a:srgbClr val="000000"/>
              </a:buClr>
              <a:buFont typeface="Arial"/>
              <a:buChar char="•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1" marL="1290960" indent="-496080">
              <a:spcBef>
                <a:spcPts val="1474"/>
              </a:spcBef>
              <a:buClr>
                <a:srgbClr val="000000"/>
              </a:buClr>
              <a:buFont typeface="Arial"/>
              <a:buChar char="–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2" marL="1986120" indent="-398160">
              <a:spcBef>
                <a:spcPts val="1474"/>
              </a:spcBef>
              <a:buClr>
                <a:srgbClr val="000000"/>
              </a:buClr>
              <a:buFont typeface="Arial"/>
              <a:buChar char="•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3" marL="2779200" indent="-396720">
              <a:spcBef>
                <a:spcPts val="1474"/>
              </a:spcBef>
              <a:buClr>
                <a:srgbClr val="000000"/>
              </a:buClr>
              <a:buFont typeface="Arial"/>
              <a:buChar char="–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4" marL="3574080" indent="-397800">
              <a:spcBef>
                <a:spcPts val="1474"/>
              </a:spcBef>
              <a:buClr>
                <a:srgbClr val="000000"/>
              </a:buClr>
              <a:buFont typeface="Arial"/>
              <a:buChar char="»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5" marL="3574080" indent="-397800">
              <a:spcBef>
                <a:spcPts val="1474"/>
              </a:spcBef>
              <a:buClr>
                <a:srgbClr val="000000"/>
              </a:buClr>
              <a:buFont typeface="Arial"/>
              <a:buChar char="»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  <a:p>
            <a:pPr lvl="6" marL="3574080" indent="-397800">
              <a:spcBef>
                <a:spcPts val="1474"/>
              </a:spcBef>
              <a:buClr>
                <a:srgbClr val="000000"/>
              </a:buClr>
              <a:buFont typeface="Arial"/>
              <a:buChar char="»"/>
              <a:tabLst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31520" y="9992880"/>
            <a:ext cx="3413160" cy="76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Autofit/>
          </a:bodyPr>
          <a:lstStyle>
            <a:lvl1pPr indent="0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998960" y="9992880"/>
            <a:ext cx="4632480" cy="76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Autofit/>
          </a:bodyPr>
          <a:lstStyle>
            <a:lvl1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0485000" y="9992880"/>
            <a:ext cx="3413160" cy="762120"/>
          </a:xfrm>
          <a:prstGeom prst="rect">
            <a:avLst/>
          </a:prstGeom>
          <a:noFill/>
          <a:ln w="0">
            <a:noFill/>
          </a:ln>
        </p:spPr>
        <p:txBody>
          <a:bodyPr lIns="167040" rIns="167040" tIns="83520" bIns="83520" anchor="t">
            <a:noAutofit/>
          </a:bodyPr>
          <a:lstStyle>
            <a:lvl1pPr indent="0" algn="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fld id="{A48BD279-2169-4053-AC0F-039F74A681E2}" type="slidenum">
              <a:rPr b="0" lang="en-US" sz="2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30240" y="546120"/>
            <a:ext cx="333360" cy="67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67040" rIns="167040" tIns="83520" bIns="8352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-1080" y="0"/>
            <a:ext cx="7741440" cy="4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67040" rIns="167040" tIns="83520" bIns="83520" anchor="t">
            <a:spAutoFit/>
          </a:bodyPr>
          <a:p>
            <a:pPr>
              <a:tabLst>
                <a:tab algn="l" pos="0"/>
                <a:tab algn="l" pos="5062680"/>
                <a:tab algn="l" pos="10125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1. ID#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ipid Metabolism, Small Molecule Biochemistry, Drug Metabolis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228600" y="765000"/>
            <a:ext cx="14096880" cy="9391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rcRect l="0" t="0" r="16653" b="0"/>
          <a:stretch/>
        </p:blipFill>
        <p:spPr>
          <a:xfrm>
            <a:off x="1143000" y="457200"/>
            <a:ext cx="12877920" cy="101775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-1800" y="0"/>
            <a:ext cx="9838440" cy="4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67040" rIns="167040" tIns="83520" bIns="83520" anchor="t">
            <a:spAutoFit/>
          </a:bodyPr>
          <a:p>
            <a:pPr>
              <a:tabLst>
                <a:tab algn="l" pos="0"/>
                <a:tab algn="l" pos="5062680"/>
                <a:tab algn="l" pos="10125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2. ID#2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etabolic Disease, Cellular Development, Connective Tissue Development and Fun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"/>
          <p:cNvSpPr/>
          <p:nvPr/>
        </p:nvSpPr>
        <p:spPr>
          <a:xfrm>
            <a:off x="3960" y="44280"/>
            <a:ext cx="11372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3. ID#3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ardiovascular System Development and Function, Cellular Development, Cellular Growth and Prolifer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rcRect l="0" t="0" r="18498" b="0"/>
          <a:stretch/>
        </p:blipFill>
        <p:spPr>
          <a:xfrm>
            <a:off x="838080" y="533520"/>
            <a:ext cx="12725640" cy="1028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3960" y="44280"/>
            <a:ext cx="8789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4. ID#4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ell Cycle, Organ Morphology, Connective Tissue Development and Function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2971800" y="533520"/>
            <a:ext cx="9134640" cy="9982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1440" y="44280"/>
            <a:ext cx="11488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5. ID#5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ellular Movement, Cell-To-Cell Signaling and Interaction, Hematological System Development and Fun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1"/>
          <a:srcRect l="0" t="0" r="15341" b="0"/>
          <a:stretch/>
        </p:blipFill>
        <p:spPr>
          <a:xfrm>
            <a:off x="1143000" y="838080"/>
            <a:ext cx="12344400" cy="960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"/>
          <p:cNvSpPr/>
          <p:nvPr/>
        </p:nvSpPr>
        <p:spPr>
          <a:xfrm>
            <a:off x="360" y="44280"/>
            <a:ext cx="793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6. ID#6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ell Death, Neurological Disease, Cellular Function and Maintenanc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2895480" y="838080"/>
            <a:ext cx="8345520" cy="9144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"/>
          <p:cNvSpPr/>
          <p:nvPr/>
        </p:nvSpPr>
        <p:spPr>
          <a:xfrm>
            <a:off x="-720" y="44280"/>
            <a:ext cx="771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7. ID#7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ipid Metabolism, Small Molecule Biochemistry, Metabolic Disea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rcRect l="0" t="0" r="17310" b="0"/>
          <a:stretch/>
        </p:blipFill>
        <p:spPr>
          <a:xfrm>
            <a:off x="1295280" y="838080"/>
            <a:ext cx="11734920" cy="9348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4320" y="44280"/>
            <a:ext cx="865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8. ID#8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arbohydrate Metabolism, Molecular Transport, Small Molecule Biochemistr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rcRect l="0" t="0" r="16653" b="0"/>
          <a:stretch/>
        </p:blipFill>
        <p:spPr>
          <a:xfrm>
            <a:off x="990720" y="493560"/>
            <a:ext cx="13258800" cy="10479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"/>
          <p:cNvSpPr/>
          <p:nvPr/>
        </p:nvSpPr>
        <p:spPr>
          <a:xfrm>
            <a:off x="4320" y="38160"/>
            <a:ext cx="6485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671480"/>
                <a:tab algn="l" pos="3343320"/>
                <a:tab algn="l" pos="5014800"/>
                <a:tab algn="l" pos="6686640"/>
                <a:tab algn="l" pos="8358120"/>
                <a:tab algn="l" pos="10029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9. ID #9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ell Cycle, Cancer, Cellular Growth and Prolifer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rcRect l="0" t="0" r="16848" b="0"/>
          <a:stretch/>
        </p:blipFill>
        <p:spPr>
          <a:xfrm>
            <a:off x="914400" y="495360"/>
            <a:ext cx="12649320" cy="1002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09T23:17:17Z</dcterms:created>
  <dc:creator>Kevin J. Yarema</dc:creator>
  <dc:description/>
  <dc:language>en-US</dc:language>
  <cp:lastModifiedBy>Yarema</cp:lastModifiedBy>
  <dcterms:modified xsi:type="dcterms:W3CDTF">2009-07-23T17:00:00Z</dcterms:modified>
  <cp:revision>34</cp:revision>
  <dc:subject/>
  <dc:title>Slide 1</dc:title>
</cp:coreProperties>
</file>